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4"/>
  </p:notesMasterIdLst>
  <p:sldIdLst>
    <p:sldId id="273" r:id="rId2"/>
    <p:sldId id="256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E32E6"/>
    <a:srgbClr val="B5FD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765" autoAdjust="0"/>
    <p:restoredTop sz="95629" autoAdjust="0"/>
  </p:normalViewPr>
  <p:slideViewPr>
    <p:cSldViewPr snapToGrid="0">
      <p:cViewPr varScale="1">
        <p:scale>
          <a:sx n="99" d="100"/>
          <a:sy n="99" d="100"/>
        </p:scale>
        <p:origin x="1360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5971389-C7A9-414B-955B-ADD21AE0D01F}" type="datetimeFigureOut">
              <a:rPr lang="en-US" smtClean="0"/>
              <a:t>1/25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4650630-B4C3-412F-9BD1-81365C8C95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98137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4650630-B4C3-412F-9BD1-81365C8C9536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62252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E995B-6834-420B-83E2-951A4DFD458D}" type="datetimeFigureOut">
              <a:rPr lang="en-US" smtClean="0"/>
              <a:t>1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19AE9-7E49-4B91-B2A4-0DF0A595B6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46460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E995B-6834-420B-83E2-951A4DFD458D}" type="datetimeFigureOut">
              <a:rPr lang="en-US" smtClean="0"/>
              <a:t>1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19AE9-7E49-4B91-B2A4-0DF0A595B6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65193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E995B-6834-420B-83E2-951A4DFD458D}" type="datetimeFigureOut">
              <a:rPr lang="en-US" smtClean="0"/>
              <a:t>1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19AE9-7E49-4B91-B2A4-0DF0A595B6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03279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E995B-6834-420B-83E2-951A4DFD458D}" type="datetimeFigureOut">
              <a:rPr lang="en-US" smtClean="0"/>
              <a:t>1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19AE9-7E49-4B91-B2A4-0DF0A595B6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68523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E995B-6834-420B-83E2-951A4DFD458D}" type="datetimeFigureOut">
              <a:rPr lang="en-US" smtClean="0"/>
              <a:t>1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19AE9-7E49-4B91-B2A4-0DF0A595B6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48150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E995B-6834-420B-83E2-951A4DFD458D}" type="datetimeFigureOut">
              <a:rPr lang="en-US" smtClean="0"/>
              <a:t>1/2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19AE9-7E49-4B91-B2A4-0DF0A595B6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7188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E995B-6834-420B-83E2-951A4DFD458D}" type="datetimeFigureOut">
              <a:rPr lang="en-US" smtClean="0"/>
              <a:t>1/25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19AE9-7E49-4B91-B2A4-0DF0A595B6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73060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E995B-6834-420B-83E2-951A4DFD458D}" type="datetimeFigureOut">
              <a:rPr lang="en-US" smtClean="0"/>
              <a:t>1/25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19AE9-7E49-4B91-B2A4-0DF0A595B6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75593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E995B-6834-420B-83E2-951A4DFD458D}" type="datetimeFigureOut">
              <a:rPr lang="en-US" smtClean="0"/>
              <a:t>1/25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19AE9-7E49-4B91-B2A4-0DF0A595B6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78779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E995B-6834-420B-83E2-951A4DFD458D}" type="datetimeFigureOut">
              <a:rPr lang="en-US" smtClean="0"/>
              <a:t>1/2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19AE9-7E49-4B91-B2A4-0DF0A595B6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44261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1E995B-6834-420B-83E2-951A4DFD458D}" type="datetimeFigureOut">
              <a:rPr lang="en-US" smtClean="0"/>
              <a:t>1/2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319AE9-7E49-4B91-B2A4-0DF0A595B6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37321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1E995B-6834-420B-83E2-951A4DFD458D}" type="datetimeFigureOut">
              <a:rPr lang="en-US" smtClean="0"/>
              <a:t>1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319AE9-7E49-4B91-B2A4-0DF0A595B6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99560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51199" y="90012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180542" y="572091"/>
            <a:ext cx="8797193" cy="4352779"/>
            <a:chOff x="180542" y="572091"/>
            <a:chExt cx="8797193" cy="4352779"/>
          </a:xfrm>
        </p:grpSpPr>
        <p:grpSp>
          <p:nvGrpSpPr>
            <p:cNvPr id="20" name="Group 19"/>
            <p:cNvGrpSpPr/>
            <p:nvPr/>
          </p:nvGrpSpPr>
          <p:grpSpPr>
            <a:xfrm>
              <a:off x="4658953" y="576135"/>
              <a:ext cx="4318782" cy="4348735"/>
              <a:chOff x="4658952" y="576134"/>
              <a:chExt cx="4318782" cy="4348734"/>
            </a:xfrm>
          </p:grpSpPr>
          <p:pic>
            <p:nvPicPr>
              <p:cNvPr id="17" name="Picture 16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4658952" y="3719087"/>
                <a:ext cx="4318782" cy="1205781"/>
              </a:xfrm>
              <a:prstGeom prst="rect">
                <a:avLst/>
              </a:prstGeom>
            </p:spPr>
          </p:pic>
          <p:pic>
            <p:nvPicPr>
              <p:cNvPr id="8" name="Picture 7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511"/>
              <a:stretch/>
            </p:blipFill>
            <p:spPr>
              <a:xfrm>
                <a:off x="4876800" y="971848"/>
                <a:ext cx="4015745" cy="2755472"/>
              </a:xfrm>
              <a:prstGeom prst="rect">
                <a:avLst/>
              </a:prstGeom>
            </p:spPr>
          </p:pic>
          <p:sp>
            <p:nvSpPr>
              <p:cNvPr id="18" name="TextBox 17"/>
              <p:cNvSpPr txBox="1"/>
              <p:nvPr/>
            </p:nvSpPr>
            <p:spPr>
              <a:xfrm>
                <a:off x="6863360" y="576134"/>
                <a:ext cx="718979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IPAH</a:t>
                </a: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7408524" y="2612162"/>
                <a:ext cx="1210588" cy="46166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og-rank test:</a:t>
                </a:r>
              </a:p>
              <a:p>
                <a:r>
                  <a:rPr lang="en-US" sz="12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&lt; 0.012</a:t>
                </a:r>
              </a:p>
            </p:txBody>
          </p:sp>
        </p:grpSp>
        <p:grpSp>
          <p:nvGrpSpPr>
            <p:cNvPr id="13" name="Group 12"/>
            <p:cNvGrpSpPr/>
            <p:nvPr/>
          </p:nvGrpSpPr>
          <p:grpSpPr>
            <a:xfrm>
              <a:off x="180542" y="572091"/>
              <a:ext cx="4294481" cy="4330209"/>
              <a:chOff x="180536" y="572086"/>
              <a:chExt cx="4294481" cy="4330209"/>
            </a:xfrm>
          </p:grpSpPr>
          <p:sp>
            <p:nvSpPr>
              <p:cNvPr id="9" name="TextBox 8"/>
              <p:cNvSpPr txBox="1"/>
              <p:nvPr/>
            </p:nvSpPr>
            <p:spPr>
              <a:xfrm>
                <a:off x="1967480" y="572086"/>
                <a:ext cx="101393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ll PAH</a:t>
                </a:r>
              </a:p>
            </p:txBody>
          </p:sp>
          <p:pic>
            <p:nvPicPr>
              <p:cNvPr id="7" name="Picture 6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8274"/>
              <a:stretch/>
            </p:blipFill>
            <p:spPr>
              <a:xfrm>
                <a:off x="374071" y="993783"/>
                <a:ext cx="3976255" cy="2699353"/>
              </a:xfrm>
              <a:prstGeom prst="rect">
                <a:avLst/>
              </a:prstGeom>
            </p:spPr>
          </p:pic>
          <p:sp>
            <p:nvSpPr>
              <p:cNvPr id="14" name="TextBox 13"/>
              <p:cNvSpPr txBox="1"/>
              <p:nvPr/>
            </p:nvSpPr>
            <p:spPr>
              <a:xfrm>
                <a:off x="2852246" y="2612162"/>
                <a:ext cx="1210588" cy="46166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og-rank test:</a:t>
                </a:r>
              </a:p>
              <a:p>
                <a:r>
                  <a:rPr lang="en-US" sz="12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&lt; 0.015</a:t>
                </a:r>
              </a:p>
            </p:txBody>
          </p:sp>
          <p:pic>
            <p:nvPicPr>
              <p:cNvPr id="11" name="Picture 10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180536" y="3719087"/>
                <a:ext cx="4294481" cy="1183208"/>
              </a:xfrm>
              <a:prstGeom prst="rect">
                <a:avLst/>
              </a:prstGeom>
            </p:spPr>
          </p:pic>
        </p:grpSp>
      </p:grpSp>
      <p:sp>
        <p:nvSpPr>
          <p:cNvPr id="15" name="TextBox 14">
            <a:extLst>
              <a:ext uri="{FF2B5EF4-FFF2-40B4-BE49-F238E27FC236}">
                <a16:creationId xmlns="" xmlns:a16="http://schemas.microsoft.com/office/drawing/2014/main" id="{10B2B9B2-E49E-4C83-804A-112F7449F825}"/>
              </a:ext>
            </a:extLst>
          </p:cNvPr>
          <p:cNvSpPr txBox="1"/>
          <p:nvPr/>
        </p:nvSpPr>
        <p:spPr>
          <a:xfrm>
            <a:off x="387573" y="572085"/>
            <a:ext cx="4707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="" xmlns:a16="http://schemas.microsoft.com/office/drawing/2014/main" id="{ADE87E38-9ECB-425E-BD76-17505C0C8B5C}"/>
              </a:ext>
            </a:extLst>
          </p:cNvPr>
          <p:cNvSpPr txBox="1"/>
          <p:nvPr/>
        </p:nvSpPr>
        <p:spPr>
          <a:xfrm>
            <a:off x="4876801" y="602516"/>
            <a:ext cx="4707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608520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" name="Group 32"/>
          <p:cNvGrpSpPr/>
          <p:nvPr/>
        </p:nvGrpSpPr>
        <p:grpSpPr>
          <a:xfrm>
            <a:off x="163103" y="901342"/>
            <a:ext cx="8856303" cy="4267499"/>
            <a:chOff x="78691" y="169817"/>
            <a:chExt cx="8856303" cy="4267499"/>
          </a:xfrm>
        </p:grpSpPr>
        <p:grpSp>
          <p:nvGrpSpPr>
            <p:cNvPr id="10" name="Group 9"/>
            <p:cNvGrpSpPr/>
            <p:nvPr/>
          </p:nvGrpSpPr>
          <p:grpSpPr>
            <a:xfrm>
              <a:off x="78691" y="169817"/>
              <a:ext cx="8856303" cy="4267499"/>
              <a:chOff x="78691" y="169817"/>
              <a:chExt cx="8856303" cy="4267499"/>
            </a:xfrm>
          </p:grpSpPr>
          <p:grpSp>
            <p:nvGrpSpPr>
              <p:cNvPr id="8" name="Group 7"/>
              <p:cNvGrpSpPr/>
              <p:nvPr/>
            </p:nvGrpSpPr>
            <p:grpSpPr>
              <a:xfrm>
                <a:off x="182880" y="169817"/>
                <a:ext cx="8752114" cy="4267499"/>
                <a:chOff x="182880" y="169817"/>
                <a:chExt cx="8752114" cy="4267499"/>
              </a:xfrm>
            </p:grpSpPr>
            <p:pic>
              <p:nvPicPr>
                <p:cNvPr id="3" name="Picture 2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1381016" y="2366433"/>
                  <a:ext cx="2746847" cy="2057899"/>
                </a:xfrm>
                <a:prstGeom prst="rect">
                  <a:avLst/>
                </a:prstGeom>
              </p:spPr>
            </p:pic>
            <p:pic>
              <p:nvPicPr>
                <p:cNvPr id="5" name="Picture 4"/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4963885" y="2366433"/>
                  <a:ext cx="2766216" cy="2070883"/>
                </a:xfrm>
                <a:prstGeom prst="rect">
                  <a:avLst/>
                </a:prstGeom>
              </p:spPr>
            </p:pic>
            <p:grpSp>
              <p:nvGrpSpPr>
                <p:cNvPr id="7" name="Group 6"/>
                <p:cNvGrpSpPr/>
                <p:nvPr/>
              </p:nvGrpSpPr>
              <p:grpSpPr>
                <a:xfrm>
                  <a:off x="182880" y="169817"/>
                  <a:ext cx="8752114" cy="1985554"/>
                  <a:chOff x="182880" y="169817"/>
                  <a:chExt cx="8752114" cy="1985554"/>
                </a:xfrm>
              </p:grpSpPr>
              <p:pic>
                <p:nvPicPr>
                  <p:cNvPr id="2" name="Picture 1"/>
                  <p:cNvPicPr>
                    <a:picLocks noChangeAspect="1"/>
                  </p:cNvPicPr>
                  <p:nvPr/>
                </p:nvPicPr>
                <p:blipFill>
                  <a:blip r:embed="rId5">
                    <a:extLst>
                      <a:ext uri="{BEBA8EAE-BF5A-486C-A8C5-ECC9F3942E4B}">
                        <a14:imgProps xmlns:a14="http://schemas.microsoft.com/office/drawing/2010/main">
                          <a14:imgLayer r:embed="rId6">
                            <a14:imgEffect>
                              <a14:sharpenSoften amount="50000"/>
                            </a14:imgEffect>
                          </a14:imgLayer>
                        </a14:imgProps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82880" y="271597"/>
                    <a:ext cx="8752114" cy="1791877"/>
                  </a:xfrm>
                  <a:prstGeom prst="rect">
                    <a:avLst/>
                  </a:prstGeom>
                </p:spPr>
              </p:pic>
              <p:sp>
                <p:nvSpPr>
                  <p:cNvPr id="4" name="Rectangle 3"/>
                  <p:cNvSpPr/>
                  <p:nvPr/>
                </p:nvSpPr>
                <p:spPr>
                  <a:xfrm>
                    <a:off x="5682342" y="169817"/>
                    <a:ext cx="104504" cy="1985554"/>
                  </a:xfrm>
                  <a:prstGeom prst="rect">
                    <a:avLst/>
                  </a:prstGeom>
                  <a:solidFill>
                    <a:srgbClr val="B5FD33">
                      <a:alpha val="50000"/>
                    </a:srgb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6" name="Rectangle 5"/>
                  <p:cNvSpPr/>
                  <p:nvPr/>
                </p:nvSpPr>
                <p:spPr>
                  <a:xfrm>
                    <a:off x="6474822" y="169817"/>
                    <a:ext cx="104504" cy="1985554"/>
                  </a:xfrm>
                  <a:prstGeom prst="rect">
                    <a:avLst/>
                  </a:prstGeom>
                  <a:solidFill>
                    <a:srgbClr val="FE32E6">
                      <a:alpha val="49804"/>
                    </a:srgb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</p:grpSp>
          <p:sp>
            <p:nvSpPr>
              <p:cNvPr id="24" name="TextBox 23"/>
              <p:cNvSpPr txBox="1"/>
              <p:nvPr/>
            </p:nvSpPr>
            <p:spPr>
              <a:xfrm>
                <a:off x="78691" y="179700"/>
                <a:ext cx="35137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78691" y="2366433"/>
                <a:ext cx="35137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</p:grpSp>
        <p:grpSp>
          <p:nvGrpSpPr>
            <p:cNvPr id="20" name="Group 19"/>
            <p:cNvGrpSpPr/>
            <p:nvPr/>
          </p:nvGrpSpPr>
          <p:grpSpPr>
            <a:xfrm>
              <a:off x="1930553" y="3867723"/>
              <a:ext cx="2123686" cy="286150"/>
              <a:chOff x="1930553" y="3867723"/>
              <a:chExt cx="2123686" cy="286150"/>
            </a:xfrm>
          </p:grpSpPr>
          <p:sp>
            <p:nvSpPr>
              <p:cNvPr id="17" name="TextBox 16"/>
              <p:cNvSpPr txBox="1"/>
              <p:nvPr/>
            </p:nvSpPr>
            <p:spPr>
              <a:xfrm>
                <a:off x="1930553" y="3867723"/>
                <a:ext cx="425116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G</a:t>
                </a:r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2766576" y="3867723"/>
                <a:ext cx="415498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A</a:t>
                </a:r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3648359" y="3876874"/>
                <a:ext cx="405880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A</a:t>
                </a:r>
              </a:p>
            </p:txBody>
          </p:sp>
        </p:grpSp>
        <p:grpSp>
          <p:nvGrpSpPr>
            <p:cNvPr id="29" name="Group 28"/>
            <p:cNvGrpSpPr/>
            <p:nvPr/>
          </p:nvGrpSpPr>
          <p:grpSpPr>
            <a:xfrm>
              <a:off x="5528037" y="3876874"/>
              <a:ext cx="2123686" cy="286150"/>
              <a:chOff x="1930553" y="3867723"/>
              <a:chExt cx="2123686" cy="286150"/>
            </a:xfrm>
          </p:grpSpPr>
          <p:sp>
            <p:nvSpPr>
              <p:cNvPr id="30" name="TextBox 29"/>
              <p:cNvSpPr txBox="1"/>
              <p:nvPr/>
            </p:nvSpPr>
            <p:spPr>
              <a:xfrm>
                <a:off x="1930553" y="3867723"/>
                <a:ext cx="425116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G</a:t>
                </a: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2766576" y="3867723"/>
                <a:ext cx="415498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A</a:t>
                </a: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3648359" y="3876874"/>
                <a:ext cx="405880" cy="276999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A</a:t>
                </a:r>
              </a:p>
            </p:txBody>
          </p:sp>
        </p:grpSp>
      </p:grpSp>
      <p:sp>
        <p:nvSpPr>
          <p:cNvPr id="35" name="TextBox 34"/>
          <p:cNvSpPr txBox="1"/>
          <p:nvPr/>
        </p:nvSpPr>
        <p:spPr>
          <a:xfrm>
            <a:off x="151199" y="90012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289864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150</TotalTime>
  <Words>32</Words>
  <Application>Microsoft Office PowerPoint</Application>
  <PresentationFormat>On-screen Show (4:3)</PresentationFormat>
  <Paragraphs>19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Johns Hopkin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 Gao</dc:creator>
  <cp:lastModifiedBy>lgao2</cp:lastModifiedBy>
  <cp:revision>135</cp:revision>
  <dcterms:created xsi:type="dcterms:W3CDTF">2019-03-30T12:36:18Z</dcterms:created>
  <dcterms:modified xsi:type="dcterms:W3CDTF">2024-01-25T19:43:50Z</dcterms:modified>
</cp:coreProperties>
</file>